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7"/>
  </p:notesMasterIdLst>
  <p:handoutMasterIdLst>
    <p:handoutMasterId r:id="rId8"/>
  </p:handoutMasterIdLst>
  <p:sldIdLst>
    <p:sldId id="295" r:id="rId2"/>
    <p:sldId id="264" r:id="rId3"/>
    <p:sldId id="304" r:id="rId4"/>
    <p:sldId id="305" r:id="rId5"/>
    <p:sldId id="292" r:id="rId6"/>
  </p:sldIdLst>
  <p:sldSz cx="6858000" cy="9906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510" autoAdjust="0"/>
    <p:restoredTop sz="94660"/>
  </p:normalViewPr>
  <p:slideViewPr>
    <p:cSldViewPr snapToGrid="0">
      <p:cViewPr>
        <p:scale>
          <a:sx n="100" d="100"/>
          <a:sy n="100" d="100"/>
        </p:scale>
        <p:origin x="1550" y="-6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handoutMaster" Target="handoutMasters/handoutMaster1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2492" tIns="46246" rIns="92492" bIns="46246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50444" y="0"/>
            <a:ext cx="2945659" cy="498056"/>
          </a:xfrm>
          <a:prstGeom prst="rect">
            <a:avLst/>
          </a:prstGeom>
        </p:spPr>
        <p:txBody>
          <a:bodyPr vert="horz" lIns="92492" tIns="46246" rIns="92492" bIns="46246" rtlCol="0"/>
          <a:lstStyle>
            <a:lvl1pPr algn="r">
              <a:defRPr sz="1200"/>
            </a:lvl1pPr>
          </a:lstStyle>
          <a:p>
            <a:fld id="{2950BA6B-6DAA-4DFE-BCD8-7775E1A9E60B}" type="datetimeFigureOut">
              <a:rPr lang="en-US" smtClean="0"/>
              <a:t>5/6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8585"/>
            <a:ext cx="2945659" cy="498055"/>
          </a:xfrm>
          <a:prstGeom prst="rect">
            <a:avLst/>
          </a:prstGeom>
        </p:spPr>
        <p:txBody>
          <a:bodyPr vert="horz" lIns="92492" tIns="46246" rIns="92492" bIns="46246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50444" y="9428585"/>
            <a:ext cx="2945659" cy="498055"/>
          </a:xfrm>
          <a:prstGeom prst="rect">
            <a:avLst/>
          </a:prstGeom>
        </p:spPr>
        <p:txBody>
          <a:bodyPr vert="horz" lIns="92492" tIns="46246" rIns="92492" bIns="46246" rtlCol="0" anchor="b"/>
          <a:lstStyle>
            <a:lvl1pPr algn="r">
              <a:defRPr sz="1200"/>
            </a:lvl1pPr>
          </a:lstStyle>
          <a:p>
            <a:fld id="{B7A4445D-449D-42A0-B0D8-B2CF0295A2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189983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453" cy="49820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670" y="0"/>
            <a:ext cx="2945453" cy="49820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8EF80C7-FDA2-4808-A276-4164C95C0DB3}" type="datetimeFigureOut">
              <a:rPr lang="en-US" smtClean="0"/>
              <a:t>5/6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39838"/>
            <a:ext cx="2317750" cy="335121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0078" y="4777344"/>
            <a:ext cx="5437519" cy="390889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429"/>
            <a:ext cx="2945453" cy="49820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670" y="9428429"/>
            <a:ext cx="2945453" cy="49820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E85F20-3B35-4D43-B1D7-57D47B9E36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477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B80500C-A9A9-4BFF-9645-AEBB02F7BA0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670371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0E85F20-3B35-4D43-B1D7-57D47B9E3608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19501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1122BB-0E73-4BCB-B56A-516297EA4A32}" type="datetimeFigureOut">
              <a:rPr lang="en-US" smtClean="0"/>
              <a:t>5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395E6-C5F8-4EA2-B811-C10DE96507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16992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1122BB-0E73-4BCB-B56A-516297EA4A32}" type="datetimeFigureOut">
              <a:rPr lang="en-US" smtClean="0"/>
              <a:t>5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395E6-C5F8-4EA2-B811-C10DE96507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86793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1122BB-0E73-4BCB-B56A-516297EA4A32}" type="datetimeFigureOut">
              <a:rPr lang="en-US" smtClean="0"/>
              <a:t>5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395E6-C5F8-4EA2-B811-C10DE96507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4517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1122BB-0E73-4BCB-B56A-516297EA4A32}" type="datetimeFigureOut">
              <a:rPr lang="en-US" smtClean="0"/>
              <a:t>5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395E6-C5F8-4EA2-B811-C10DE96507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26816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1122BB-0E73-4BCB-B56A-516297EA4A32}" type="datetimeFigureOut">
              <a:rPr lang="en-US" smtClean="0"/>
              <a:t>5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395E6-C5F8-4EA2-B811-C10DE96507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47356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1122BB-0E73-4BCB-B56A-516297EA4A32}" type="datetimeFigureOut">
              <a:rPr lang="en-US" smtClean="0"/>
              <a:t>5/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395E6-C5F8-4EA2-B811-C10DE96507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18470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1122BB-0E73-4BCB-B56A-516297EA4A32}" type="datetimeFigureOut">
              <a:rPr lang="en-US" smtClean="0"/>
              <a:t>5/6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395E6-C5F8-4EA2-B811-C10DE96507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15747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1122BB-0E73-4BCB-B56A-516297EA4A32}" type="datetimeFigureOut">
              <a:rPr lang="en-US" smtClean="0"/>
              <a:t>5/6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395E6-C5F8-4EA2-B811-C10DE96507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76711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1122BB-0E73-4BCB-B56A-516297EA4A32}" type="datetimeFigureOut">
              <a:rPr lang="en-US" smtClean="0"/>
              <a:t>5/6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395E6-C5F8-4EA2-B811-C10DE96507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11646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1122BB-0E73-4BCB-B56A-516297EA4A32}" type="datetimeFigureOut">
              <a:rPr lang="en-US" smtClean="0"/>
              <a:t>5/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395E6-C5F8-4EA2-B811-C10DE96507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19775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1122BB-0E73-4BCB-B56A-516297EA4A32}" type="datetimeFigureOut">
              <a:rPr lang="en-US" smtClean="0"/>
              <a:t>5/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395E6-C5F8-4EA2-B811-C10DE96507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0763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1122BB-0E73-4BCB-B56A-516297EA4A32}" type="datetimeFigureOut">
              <a:rPr lang="en-US" smtClean="0"/>
              <a:t>5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A395E6-C5F8-4EA2-B811-C10DE96507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37712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oleObject" Target="../embeddings/oleObject3.bin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6" name="Picture 10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94696" y="1481933"/>
            <a:ext cx="1418591" cy="1418591"/>
          </a:xfrm>
          <a:prstGeom prst="rect">
            <a:avLst/>
          </a:prstGeom>
        </p:spPr>
      </p:pic>
      <p:pic>
        <p:nvPicPr>
          <p:cNvPr id="95" name="Picture 9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7903" y="1485717"/>
            <a:ext cx="1411430" cy="1411430"/>
          </a:xfrm>
          <a:prstGeom prst="rect">
            <a:avLst/>
          </a:prstGeom>
        </p:spPr>
      </p:pic>
      <p:cxnSp>
        <p:nvCxnSpPr>
          <p:cNvPr id="3" name="Straight Arrow Connector 2"/>
          <p:cNvCxnSpPr/>
          <p:nvPr/>
        </p:nvCxnSpPr>
        <p:spPr>
          <a:xfrm>
            <a:off x="1743018" y="2459128"/>
            <a:ext cx="22225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 rot="16200000">
            <a:off x="4754300" y="1554775"/>
            <a:ext cx="12003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Straight Arrow Connector 13"/>
          <p:cNvCxnSpPr/>
          <p:nvPr/>
        </p:nvCxnSpPr>
        <p:spPr>
          <a:xfrm>
            <a:off x="3336330" y="2507000"/>
            <a:ext cx="22225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Straight Arrow Connector 14"/>
          <p:cNvCxnSpPr/>
          <p:nvPr/>
        </p:nvCxnSpPr>
        <p:spPr>
          <a:xfrm>
            <a:off x="4989395" y="2570102"/>
            <a:ext cx="22225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Straight Arrow Connector 20"/>
          <p:cNvCxnSpPr/>
          <p:nvPr/>
        </p:nvCxnSpPr>
        <p:spPr>
          <a:xfrm>
            <a:off x="5934602" y="3122007"/>
            <a:ext cx="0" cy="28070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3" name="TextBox 92"/>
          <p:cNvSpPr txBox="1"/>
          <p:nvPr/>
        </p:nvSpPr>
        <p:spPr>
          <a:xfrm rot="16200000">
            <a:off x="-362227" y="1799625"/>
            <a:ext cx="12681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sp>
        <p:nvSpPr>
          <p:cNvPr id="94" name="TextBox 93"/>
          <p:cNvSpPr txBox="1"/>
          <p:nvPr/>
        </p:nvSpPr>
        <p:spPr>
          <a:xfrm>
            <a:off x="677117" y="2844897"/>
            <a:ext cx="76255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</a:p>
        </p:txBody>
      </p:sp>
      <p:grpSp>
        <p:nvGrpSpPr>
          <p:cNvPr id="87" name="Group 86"/>
          <p:cNvGrpSpPr/>
          <p:nvPr/>
        </p:nvGrpSpPr>
        <p:grpSpPr>
          <a:xfrm>
            <a:off x="5007460" y="1115500"/>
            <a:ext cx="1752056" cy="1980617"/>
            <a:chOff x="4090640" y="4762124"/>
            <a:chExt cx="1947388" cy="2033932"/>
          </a:xfrm>
        </p:grpSpPr>
        <p:grpSp>
          <p:nvGrpSpPr>
            <p:cNvPr id="99" name="Group 98"/>
            <p:cNvGrpSpPr/>
            <p:nvPr/>
          </p:nvGrpSpPr>
          <p:grpSpPr>
            <a:xfrm>
              <a:off x="4090640" y="4762124"/>
              <a:ext cx="1947388" cy="2033932"/>
              <a:chOff x="1826904" y="332159"/>
              <a:chExt cx="1900469" cy="1895930"/>
            </a:xfrm>
          </p:grpSpPr>
          <p:sp>
            <p:nvSpPr>
              <p:cNvPr id="101" name="TextBox 100"/>
              <p:cNvSpPr txBox="1"/>
              <p:nvPr/>
            </p:nvSpPr>
            <p:spPr>
              <a:xfrm>
                <a:off x="2459208" y="1997258"/>
                <a:ext cx="1268165" cy="2308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ive/dead</a:t>
                </a:r>
              </a:p>
            </p:txBody>
          </p:sp>
          <p:sp>
            <p:nvSpPr>
              <p:cNvPr id="102" name="TextBox 101"/>
              <p:cNvSpPr txBox="1"/>
              <p:nvPr/>
            </p:nvSpPr>
            <p:spPr>
              <a:xfrm rot="16200000">
                <a:off x="1312646" y="846417"/>
                <a:ext cx="1268165" cy="23965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3</a:t>
                </a:r>
              </a:p>
            </p:txBody>
          </p:sp>
        </p:grpSp>
        <p:sp>
          <p:nvSpPr>
            <p:cNvPr id="104" name="TextBox 103"/>
            <p:cNvSpPr txBox="1"/>
            <p:nvPr/>
          </p:nvSpPr>
          <p:spPr>
            <a:xfrm>
              <a:off x="4487994" y="5429715"/>
              <a:ext cx="721695" cy="2498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Live CD3</a:t>
              </a:r>
            </a:p>
          </p:txBody>
        </p:sp>
      </p:grpSp>
      <p:sp>
        <p:nvSpPr>
          <p:cNvPr id="109" name="TextBox 108"/>
          <p:cNvSpPr txBox="1"/>
          <p:nvPr/>
        </p:nvSpPr>
        <p:spPr>
          <a:xfrm rot="16200000">
            <a:off x="2881291" y="1726377"/>
            <a:ext cx="12681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FSC-W</a:t>
            </a:r>
          </a:p>
        </p:txBody>
      </p:sp>
      <p:sp>
        <p:nvSpPr>
          <p:cNvPr id="110" name="TextBox 109"/>
          <p:cNvSpPr txBox="1"/>
          <p:nvPr/>
        </p:nvSpPr>
        <p:spPr>
          <a:xfrm>
            <a:off x="4054730" y="2909572"/>
            <a:ext cx="76255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FSC-H</a:t>
            </a:r>
          </a:p>
        </p:txBody>
      </p:sp>
      <p:cxnSp>
        <p:nvCxnSpPr>
          <p:cNvPr id="123" name="Straight Arrow Connector 122"/>
          <p:cNvCxnSpPr>
            <a:cxnSpLocks/>
          </p:cNvCxnSpPr>
          <p:nvPr/>
        </p:nvCxnSpPr>
        <p:spPr>
          <a:xfrm flipH="1">
            <a:off x="4747598" y="4495743"/>
            <a:ext cx="234924" cy="234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4" name="Straight Arrow Connector 133"/>
          <p:cNvCxnSpPr>
            <a:cxnSpLocks/>
          </p:cNvCxnSpPr>
          <p:nvPr/>
        </p:nvCxnSpPr>
        <p:spPr>
          <a:xfrm flipH="1">
            <a:off x="2771986" y="4502855"/>
            <a:ext cx="234924" cy="234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8" name="Group 7"/>
          <p:cNvGrpSpPr/>
          <p:nvPr/>
        </p:nvGrpSpPr>
        <p:grpSpPr>
          <a:xfrm>
            <a:off x="1794018" y="1187958"/>
            <a:ext cx="1395759" cy="1936828"/>
            <a:chOff x="1706127" y="163196"/>
            <a:chExt cx="1395759" cy="1936828"/>
          </a:xfrm>
        </p:grpSpPr>
        <p:sp>
          <p:nvSpPr>
            <p:cNvPr id="107" name="TextBox 106"/>
            <p:cNvSpPr txBox="1"/>
            <p:nvPr/>
          </p:nvSpPr>
          <p:spPr>
            <a:xfrm rot="16200000">
              <a:off x="1187460" y="681863"/>
              <a:ext cx="126816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SSC-W</a:t>
              </a:r>
            </a:p>
          </p:txBody>
        </p:sp>
        <p:sp>
          <p:nvSpPr>
            <p:cNvPr id="108" name="TextBox 107"/>
            <p:cNvSpPr txBox="1"/>
            <p:nvPr/>
          </p:nvSpPr>
          <p:spPr>
            <a:xfrm>
              <a:off x="2339335" y="1869192"/>
              <a:ext cx="76255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SSC-H</a:t>
              </a:r>
            </a:p>
          </p:txBody>
        </p:sp>
      </p:grpSp>
      <p:grpSp>
        <p:nvGrpSpPr>
          <p:cNvPr id="11" name="Group 10"/>
          <p:cNvGrpSpPr/>
          <p:nvPr/>
        </p:nvGrpSpPr>
        <p:grpSpPr>
          <a:xfrm>
            <a:off x="4817281" y="3440640"/>
            <a:ext cx="1942235" cy="1919664"/>
            <a:chOff x="5217361" y="2515865"/>
            <a:chExt cx="1640639" cy="1604056"/>
          </a:xfrm>
        </p:grpSpPr>
        <p:sp>
          <p:nvSpPr>
            <p:cNvPr id="148" name="TextBox 147"/>
            <p:cNvSpPr txBox="1"/>
            <p:nvPr/>
          </p:nvSpPr>
          <p:spPr>
            <a:xfrm rot="16200000">
              <a:off x="4971758" y="2877553"/>
              <a:ext cx="722038" cy="230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</a:p>
          </p:txBody>
        </p:sp>
        <p:sp>
          <p:nvSpPr>
            <p:cNvPr id="149" name="TextBox 148"/>
            <p:cNvSpPr txBox="1"/>
            <p:nvPr/>
          </p:nvSpPr>
          <p:spPr>
            <a:xfrm>
              <a:off x="5855109" y="3891128"/>
              <a:ext cx="1002891" cy="22879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CD3</a:t>
              </a:r>
            </a:p>
          </p:txBody>
        </p:sp>
        <p:pic>
          <p:nvPicPr>
            <p:cNvPr id="150" name="Picture 149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333553" y="2515865"/>
              <a:ext cx="1386266" cy="1386266"/>
            </a:xfrm>
            <a:prstGeom prst="rect">
              <a:avLst/>
            </a:prstGeom>
          </p:spPr>
        </p:pic>
        <p:sp>
          <p:nvSpPr>
            <p:cNvPr id="5" name="Rectangle 4"/>
            <p:cNvSpPr/>
            <p:nvPr/>
          </p:nvSpPr>
          <p:spPr>
            <a:xfrm>
              <a:off x="6174809" y="3165287"/>
              <a:ext cx="43313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900" b="1" dirty="0"/>
                <a:t>CD4+</a:t>
              </a:r>
            </a:p>
          </p:txBody>
        </p:sp>
        <p:sp>
          <p:nvSpPr>
            <p:cNvPr id="151" name="Rectangle 150"/>
            <p:cNvSpPr/>
            <p:nvPr/>
          </p:nvSpPr>
          <p:spPr>
            <a:xfrm>
              <a:off x="6188980" y="3594136"/>
              <a:ext cx="410690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900" b="1" dirty="0"/>
                <a:t>CD4-</a:t>
              </a:r>
            </a:p>
          </p:txBody>
        </p:sp>
      </p:grpSp>
      <p:grpSp>
        <p:nvGrpSpPr>
          <p:cNvPr id="10" name="Group 9"/>
          <p:cNvGrpSpPr/>
          <p:nvPr/>
        </p:nvGrpSpPr>
        <p:grpSpPr>
          <a:xfrm>
            <a:off x="2855111" y="3434462"/>
            <a:ext cx="1766427" cy="1610498"/>
            <a:chOff x="3546788" y="2501595"/>
            <a:chExt cx="1556100" cy="1390926"/>
          </a:xfrm>
        </p:grpSpPr>
        <p:pic>
          <p:nvPicPr>
            <p:cNvPr id="152" name="Picture 151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711962" y="2501595"/>
              <a:ext cx="1390926" cy="1390926"/>
            </a:xfrm>
            <a:prstGeom prst="rect">
              <a:avLst/>
            </a:prstGeom>
          </p:spPr>
        </p:pic>
        <p:sp>
          <p:nvSpPr>
            <p:cNvPr id="153" name="TextBox 152"/>
            <p:cNvSpPr txBox="1"/>
            <p:nvPr/>
          </p:nvSpPr>
          <p:spPr>
            <a:xfrm rot="16200000">
              <a:off x="3301185" y="2981070"/>
              <a:ext cx="722038" cy="230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CD45RO</a:t>
              </a:r>
            </a:p>
          </p:txBody>
        </p:sp>
      </p:grpSp>
      <p:sp>
        <p:nvSpPr>
          <p:cNvPr id="154" name="TextBox 153"/>
          <p:cNvSpPr txBox="1"/>
          <p:nvPr/>
        </p:nvSpPr>
        <p:spPr>
          <a:xfrm>
            <a:off x="3534247" y="4992692"/>
            <a:ext cx="1002891" cy="2287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</a:p>
        </p:txBody>
      </p:sp>
      <p:sp>
        <p:nvSpPr>
          <p:cNvPr id="6" name="Rectangle 5"/>
          <p:cNvSpPr/>
          <p:nvPr/>
        </p:nvSpPr>
        <p:spPr>
          <a:xfrm>
            <a:off x="3501733" y="3924060"/>
            <a:ext cx="720069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CD45RO+</a:t>
            </a:r>
          </a:p>
        </p:txBody>
      </p:sp>
      <p:sp>
        <p:nvSpPr>
          <p:cNvPr id="158" name="Rectangle 157"/>
          <p:cNvSpPr/>
          <p:nvPr/>
        </p:nvSpPr>
        <p:spPr>
          <a:xfrm>
            <a:off x="3579329" y="4624319"/>
            <a:ext cx="691215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CD45RO-</a:t>
            </a:r>
          </a:p>
        </p:txBody>
      </p:sp>
      <p:pic>
        <p:nvPicPr>
          <p:cNvPr id="118" name="Picture 11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916664" y="1492408"/>
            <a:ext cx="1429382" cy="1429382"/>
          </a:xfrm>
          <a:prstGeom prst="rect">
            <a:avLst/>
          </a:prstGeom>
        </p:spPr>
      </p:pic>
      <p:sp>
        <p:nvSpPr>
          <p:cNvPr id="119" name="TextBox 118"/>
          <p:cNvSpPr txBox="1"/>
          <p:nvPr/>
        </p:nvSpPr>
        <p:spPr>
          <a:xfrm>
            <a:off x="2232504" y="2176348"/>
            <a:ext cx="72968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inglets 1</a:t>
            </a:r>
          </a:p>
        </p:txBody>
      </p:sp>
      <p:pic>
        <p:nvPicPr>
          <p:cNvPr id="122" name="Picture 12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510225" y="1492408"/>
            <a:ext cx="1413995" cy="1413995"/>
          </a:xfrm>
          <a:prstGeom prst="rect">
            <a:avLst/>
          </a:prstGeom>
        </p:spPr>
      </p:pic>
      <p:sp>
        <p:nvSpPr>
          <p:cNvPr id="121" name="TextBox 120"/>
          <p:cNvSpPr txBox="1"/>
          <p:nvPr/>
        </p:nvSpPr>
        <p:spPr>
          <a:xfrm>
            <a:off x="4016516" y="2166385"/>
            <a:ext cx="721529" cy="234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inglets 2</a:t>
            </a:r>
          </a:p>
        </p:txBody>
      </p:sp>
      <p:grpSp>
        <p:nvGrpSpPr>
          <p:cNvPr id="9" name="Group 8"/>
          <p:cNvGrpSpPr/>
          <p:nvPr/>
        </p:nvGrpSpPr>
        <p:grpSpPr>
          <a:xfrm>
            <a:off x="923634" y="3460710"/>
            <a:ext cx="1910129" cy="1733307"/>
            <a:chOff x="1576154" y="2438097"/>
            <a:chExt cx="1910129" cy="1733307"/>
          </a:xfrm>
        </p:grpSpPr>
        <p:sp>
          <p:nvSpPr>
            <p:cNvPr id="133" name="TextBox 132"/>
            <p:cNvSpPr txBox="1"/>
            <p:nvPr/>
          </p:nvSpPr>
          <p:spPr>
            <a:xfrm>
              <a:off x="2180823" y="3947696"/>
              <a:ext cx="1102374" cy="2237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CCR6</a:t>
              </a:r>
            </a:p>
          </p:txBody>
        </p:sp>
        <p:sp>
          <p:nvSpPr>
            <p:cNvPr id="147" name="TextBox 146"/>
            <p:cNvSpPr txBox="1"/>
            <p:nvPr/>
          </p:nvSpPr>
          <p:spPr>
            <a:xfrm rot="16200000">
              <a:off x="1330551" y="2940281"/>
              <a:ext cx="722038" cy="230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CXCR3</a:t>
              </a:r>
            </a:p>
          </p:txBody>
        </p:sp>
        <p:pic>
          <p:nvPicPr>
            <p:cNvPr id="157" name="Picture 156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1729333" y="2438097"/>
              <a:ext cx="1558876" cy="1558876"/>
            </a:xfrm>
            <a:prstGeom prst="rect">
              <a:avLst/>
            </a:prstGeom>
          </p:spPr>
        </p:pic>
        <p:sp>
          <p:nvSpPr>
            <p:cNvPr id="125" name="TextBox 124"/>
            <p:cNvSpPr txBox="1"/>
            <p:nvPr/>
          </p:nvSpPr>
          <p:spPr>
            <a:xfrm>
              <a:off x="1779766" y="2795234"/>
              <a:ext cx="67511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Th1</a:t>
              </a:r>
            </a:p>
          </p:txBody>
        </p:sp>
        <p:sp>
          <p:nvSpPr>
            <p:cNvPr id="126" name="TextBox 125"/>
            <p:cNvSpPr txBox="1"/>
            <p:nvPr/>
          </p:nvSpPr>
          <p:spPr>
            <a:xfrm>
              <a:off x="1758315" y="3689941"/>
              <a:ext cx="67511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Th2</a:t>
              </a: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2811170" y="3607277"/>
              <a:ext cx="67511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Th17</a:t>
              </a:r>
            </a:p>
          </p:txBody>
        </p:sp>
      </p:grpSp>
      <p:sp>
        <p:nvSpPr>
          <p:cNvPr id="7" name="Rectangle 6"/>
          <p:cNvSpPr/>
          <p:nvPr/>
        </p:nvSpPr>
        <p:spPr>
          <a:xfrm>
            <a:off x="304211" y="5833386"/>
            <a:ext cx="6286488" cy="61311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Bef>
                <a:spcPts val="600"/>
              </a:spcBef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.  Gating strategy for flow cytometric analysis of CD4+ memory </a:t>
            </a:r>
            <a:r>
              <a:rPr lang="en-US" sz="1200" b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ells and Th1, Th2 and Th17 subsets.</a:t>
            </a:r>
            <a:endParaRPr lang="en-US" sz="1200" dirty="0">
              <a:latin typeface="Times New Roman" panose="02020603050405020304" pitchFamily="18" charset="0"/>
              <a:ea typeface="Calibri" panose="020F0502020204030204" pitchFamily="34" charset="0"/>
              <a:cs typeface="Vrinda"/>
            </a:endParaRPr>
          </a:p>
        </p:txBody>
      </p:sp>
    </p:spTree>
    <p:extLst>
      <p:ext uri="{BB962C8B-B14F-4D97-AF65-F5344CB8AC3E}">
        <p14:creationId xmlns:p14="http://schemas.microsoft.com/office/powerpoint/2010/main" val="3137185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53010098"/>
              </p:ext>
            </p:extLst>
          </p:nvPr>
        </p:nvGraphicFramePr>
        <p:xfrm>
          <a:off x="392113" y="1524000"/>
          <a:ext cx="6465887" cy="27320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2" imgW="7476417" imgH="3151348" progId="Prism6.Document">
                  <p:embed/>
                </p:oleObj>
              </mc:Choice>
              <mc:Fallback>
                <p:oleObj name="Prism 6" r:id="rId2" imgW="7476417" imgH="3151348" progId="Prism6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92113" y="1524000"/>
                        <a:ext cx="6465887" cy="27320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Rectangle 1"/>
          <p:cNvSpPr/>
          <p:nvPr/>
        </p:nvSpPr>
        <p:spPr>
          <a:xfrm>
            <a:off x="176463" y="4708459"/>
            <a:ext cx="6570701" cy="172111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IL-17A production from PBMCs depleted of </a:t>
            </a:r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+ Th </a:t>
            </a:r>
            <a:r>
              <a:rPr lang="fr-F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response to stimulation </a:t>
            </a:r>
            <a:r>
              <a:rPr lang="fr-F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mLT, LTB and </a:t>
            </a:r>
            <a:r>
              <a:rPr lang="fr-F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Fs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L-17A concentrations in cultures with PBMCs and PBMCs depleted of CD4+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from ETEC infected patients on day 7 after hospitalization stimulated with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dmLT (n=6),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LTB (n=6),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S5 (n=1, open circle) or CS6 (n=1, open square). Each symbol and line represents data from one participant. Statistical analysis was performed using the Wilcoxon matched-pairs signed rank test.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*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0.05.</a:t>
            </a:r>
            <a:endParaRPr lang="en-US" sz="1200" dirty="0"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231130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81609540"/>
              </p:ext>
            </p:extLst>
          </p:nvPr>
        </p:nvGraphicFramePr>
        <p:xfrm>
          <a:off x="303480" y="1611086"/>
          <a:ext cx="6251040" cy="28037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2" imgW="7150134" imgH="3205500" progId="Prism6.Document">
                  <p:embed/>
                </p:oleObj>
              </mc:Choice>
              <mc:Fallback>
                <p:oleObj name="Prism 6" r:id="rId2" imgW="7150134" imgH="3205500" progId="Prism6.Document">
                  <p:embed/>
                  <p:pic>
                    <p:nvPicPr>
                      <p:cNvPr id="9" name="Object 8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03480" y="1611086"/>
                        <a:ext cx="6251040" cy="28037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71D7CC8E-62BE-4059-9813-4D7039364745}"/>
              </a:ext>
            </a:extLst>
          </p:cNvPr>
          <p:cNvSpPr txBox="1"/>
          <p:nvPr/>
        </p:nvSpPr>
        <p:spPr>
          <a:xfrm>
            <a:off x="1799771" y="1474730"/>
            <a:ext cx="6839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b="1" dirty="0" err="1"/>
              <a:t>dmLT</a:t>
            </a:r>
            <a:endParaRPr lang="sv-SE" b="1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9160F38-3C1A-4ED9-80FD-5ECF22961243}"/>
              </a:ext>
            </a:extLst>
          </p:cNvPr>
          <p:cNvSpPr txBox="1"/>
          <p:nvPr/>
        </p:nvSpPr>
        <p:spPr>
          <a:xfrm>
            <a:off x="4913085" y="1474730"/>
            <a:ext cx="5091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b="1" dirty="0"/>
              <a:t>LTB</a:t>
            </a:r>
          </a:p>
        </p:txBody>
      </p:sp>
      <p:sp>
        <p:nvSpPr>
          <p:cNvPr id="3" name="Rectangle 2"/>
          <p:cNvSpPr/>
          <p:nvPr/>
        </p:nvSpPr>
        <p:spPr>
          <a:xfrm>
            <a:off x="303480" y="4606613"/>
            <a:ext cx="6127297" cy="11665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Bef>
                <a:spcPts val="600"/>
              </a:spcBef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3. Correlation between IL-17A and IFN-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γ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responses to dmLT and LTB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rrelation between the maximum fold-increases in cytokines (maximum responses at any time point divided by the response on day 2); (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IL-17A vs. IFN-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sym typeface="Symbol" panose="05050102010706020507" pitchFamily="18" charset="2"/>
              </a:rPr>
              <a:t>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o dmLT and (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IL-17A vs. IFN-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sym typeface="Symbol" panose="05050102010706020507" pitchFamily="18" charset="2"/>
              </a:rPr>
              <a:t>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o LTB. Statistical analysis was performed using the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pearman test. </a:t>
            </a:r>
            <a:endParaRPr lang="en-US" sz="1200" dirty="0">
              <a:latin typeface="Times New Roman" panose="02020603050405020304" pitchFamily="18" charset="0"/>
              <a:ea typeface="Calibri" panose="020F0502020204030204" pitchFamily="34" charset="0"/>
              <a:cs typeface="Vrinda"/>
            </a:endParaRPr>
          </a:p>
        </p:txBody>
      </p:sp>
    </p:spTree>
    <p:extLst>
      <p:ext uri="{BB962C8B-B14F-4D97-AF65-F5344CB8AC3E}">
        <p14:creationId xmlns:p14="http://schemas.microsoft.com/office/powerpoint/2010/main" val="67409270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7660024"/>
              </p:ext>
            </p:extLst>
          </p:nvPr>
        </p:nvGraphicFramePr>
        <p:xfrm>
          <a:off x="861319" y="-113736"/>
          <a:ext cx="4316500" cy="775344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4921255" imgH="8831236" progId="Prism9.Document">
                  <p:embed/>
                </p:oleObj>
              </mc:Choice>
              <mc:Fallback>
                <p:oleObj name="Prism 9" r:id="rId2" imgW="4921255" imgH="8831236" progId="Prism9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861319" y="-113736"/>
                        <a:ext cx="4316500" cy="775344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Rectangle 2"/>
          <p:cNvSpPr/>
          <p:nvPr/>
        </p:nvSpPr>
        <p:spPr>
          <a:xfrm>
            <a:off x="179690" y="7540648"/>
            <a:ext cx="6498620" cy="2275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. IL-17A and IFN-γ responses to and adjuvant functions of different derivatives of LT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The adjuvant effect of dmLT and LTE112K on IL-17A responses to PHA evaluated by stimulation of PBMCs collected from healthy controls (n=9). Bars represent median + 95% confidence interval. IL-17A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IFN-γ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responses to dmLT, LT, LTE112K, LTB1 (produced by Scandinavian Biopharma) and LTB2 (produced by Tulane University) in PBMCs collected from patients infected with LT+ ETEC on day 2 and 7 after hospitalization (n=12). Statistical analysis was performed using the Mann-Whitney test.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*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0.05, 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0.01, 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0.001, ns; not significant;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gt;0.05.</a:t>
            </a:r>
            <a:endParaRPr lang="en-US" sz="1200" dirty="0"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1132847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54296572"/>
              </p:ext>
            </p:extLst>
          </p:nvPr>
        </p:nvGraphicFramePr>
        <p:xfrm>
          <a:off x="825976" y="908736"/>
          <a:ext cx="5483384" cy="462997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7783651" imgH="6567860" progId="Prism9.Document">
                  <p:embed/>
                </p:oleObj>
              </mc:Choice>
              <mc:Fallback>
                <p:oleObj name="Prism 9" r:id="rId3" imgW="7783651" imgH="6567860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25976" y="908736"/>
                        <a:ext cx="5483384" cy="462997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957D9B6F-08D2-4068-B613-7FC35EBE67C2}"/>
              </a:ext>
            </a:extLst>
          </p:cNvPr>
          <p:cNvSpPr txBox="1"/>
          <p:nvPr/>
        </p:nvSpPr>
        <p:spPr>
          <a:xfrm>
            <a:off x="132082" y="1905226"/>
            <a:ext cx="787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b="1" dirty="0"/>
              <a:t>IL-17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E03F841-8D63-42E4-ADA0-42669EE207B6}"/>
              </a:ext>
            </a:extLst>
          </p:cNvPr>
          <p:cNvSpPr txBox="1"/>
          <p:nvPr/>
        </p:nvSpPr>
        <p:spPr>
          <a:xfrm>
            <a:off x="237880" y="4292464"/>
            <a:ext cx="6815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b="1" dirty="0"/>
              <a:t>IFN-</a:t>
            </a:r>
            <a:r>
              <a:rPr lang="el-GR" b="1" dirty="0"/>
              <a:t>γ</a:t>
            </a:r>
            <a:endParaRPr lang="sv-SE" b="1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5DB28BB-EA29-4C90-B3B5-D618D20D7B7E}"/>
              </a:ext>
            </a:extLst>
          </p:cNvPr>
          <p:cNvSpPr txBox="1"/>
          <p:nvPr/>
        </p:nvSpPr>
        <p:spPr>
          <a:xfrm>
            <a:off x="2094049" y="853610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b="1" dirty="0"/>
              <a:t>ALS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C5277CBC-B704-4875-AF9A-A2114A6B30BE}"/>
              </a:ext>
            </a:extLst>
          </p:cNvPr>
          <p:cNvSpPr txBox="1"/>
          <p:nvPr/>
        </p:nvSpPr>
        <p:spPr>
          <a:xfrm>
            <a:off x="4711307" y="853610"/>
            <a:ext cx="8707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b="1" dirty="0"/>
              <a:t>Plasma</a:t>
            </a:r>
          </a:p>
        </p:txBody>
      </p:sp>
      <p:sp>
        <p:nvSpPr>
          <p:cNvPr id="6" name="Rectangle 5"/>
          <p:cNvSpPr/>
          <p:nvPr/>
        </p:nvSpPr>
        <p:spPr>
          <a:xfrm>
            <a:off x="342900" y="5776719"/>
            <a:ext cx="6297929" cy="14477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Supplementary figure 5. Correlation between IL-17A and IFN-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γ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 responses to LTB and IgA responses to LTB in ALS and plasma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Correlation between the maximum fold-increases in cytokines and IgA (maximum responses at any time point divided by the response on day 2); (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) IL-17A vs. ALS IgA, (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) IL-17A vs. plasma IgA, (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C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) IFN-γ vs. ALS IgA and (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D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) IFN-γ vs. plasma IgA. Statistical analysis was performed using the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Spearman test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6735942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063</TotalTime>
  <Words>483</Words>
  <Application>Microsoft Office PowerPoint</Application>
  <PresentationFormat>A4 Paper (210x297 mm)</PresentationFormat>
  <Paragraphs>37</Paragraphs>
  <Slides>5</Slides>
  <Notes>2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3</vt:i4>
      </vt:variant>
      <vt:variant>
        <vt:lpstr>Slide Titles</vt:lpstr>
      </vt:variant>
      <vt:variant>
        <vt:i4>5</vt:i4>
      </vt:variant>
    </vt:vector>
  </HeadingPairs>
  <TitlesOfParts>
    <vt:vector size="13" baseType="lpstr">
      <vt:lpstr>Arial</vt:lpstr>
      <vt:lpstr>Calibri</vt:lpstr>
      <vt:lpstr>Calibri Light</vt:lpstr>
      <vt:lpstr>Times New Roman</vt:lpstr>
      <vt:lpstr>Office Theme</vt:lpstr>
      <vt:lpstr>Prism 6</vt:lpstr>
      <vt:lpstr>Prism 9</vt:lpstr>
      <vt:lpstr>GraphPad Prism 9 Project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jahan Akhtar</dc:creator>
  <cp:lastModifiedBy>Anna Lundgren</cp:lastModifiedBy>
  <cp:revision>378</cp:revision>
  <cp:lastPrinted>2022-02-27T09:24:26Z</cp:lastPrinted>
  <dcterms:created xsi:type="dcterms:W3CDTF">2020-02-25T07:37:14Z</dcterms:created>
  <dcterms:modified xsi:type="dcterms:W3CDTF">2023-05-06T19:52:19Z</dcterms:modified>
</cp:coreProperties>
</file>